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0C29D-7EBF-4E13-AF86-BEB85378C5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10FAE-FBC4-411A-8BE7-CA6BC70CE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7CE6F-634E-4CB5-96CA-7358D9755D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633E2-3BC8-49A7-85F6-D70055A497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69796-77B5-4F14-911F-F3DC9B8862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141CA-7F26-4F0C-999D-206C12CAB7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D1106-BA6A-4D79-B2A6-BB80AD6DCE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1663B-00BF-493A-8455-D8874E262C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DC575-625A-4488-8755-00D5188300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7EC52-2EA7-477F-85E5-2229C0E351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2A67C-D243-4E99-A168-2E94549ABC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380BC-D254-4498-ABE1-4495D0A80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227F8E-9310-4661-93D8-A73AF4AD78D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76320" y="1108080"/>
            <a:ext cx="4717800" cy="30034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4660920" y="1066680"/>
            <a:ext cx="4435560" cy="308628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7"/>
          <p:cNvSpPr/>
          <p:nvPr/>
        </p:nvSpPr>
        <p:spPr>
          <a:xfrm>
            <a:off x="1863720" y="92376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8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8"/>
          <p:cNvSpPr/>
          <p:nvPr/>
        </p:nvSpPr>
        <p:spPr>
          <a:xfrm>
            <a:off x="5943600" y="92376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L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"/>
          <p:cNvSpPr/>
          <p:nvPr/>
        </p:nvSpPr>
        <p:spPr>
          <a:xfrm>
            <a:off x="762120" y="5054760"/>
            <a:ext cx="7391160" cy="73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A-2H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does not prevent graft vs. host disease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n day 0, BDF1 mice were transferred 4x10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ells of B6 spleen and lymph node cells, followed by no treatment or treatment with either control Fc, or whole  2A-2H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(400 mg i.v.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n day 0 and day 4. On day 9, don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nti-host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TL activity was tested by 51Cr-release assay against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A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H2d expressing P815 cells and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B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EL4 cells that do not express H2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12" descr=""/>
          <p:cNvPicPr/>
          <p:nvPr/>
        </p:nvPicPr>
        <p:blipFill>
          <a:blip r:embed="rId3"/>
          <a:srcRect l="11827" t="11103" r="53607" b="7631"/>
          <a:stretch/>
        </p:blipFill>
        <p:spPr>
          <a:xfrm>
            <a:off x="7010280" y="237960"/>
            <a:ext cx="679680" cy="137160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87"/>
          <p:cNvSpPr/>
          <p:nvPr/>
        </p:nvSpPr>
        <p:spPr>
          <a:xfrm>
            <a:off x="7661160" y="1273320"/>
            <a:ext cx="75960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2A-2H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7"/>
          <p:cNvSpPr/>
          <p:nvPr/>
        </p:nvSpPr>
        <p:spPr>
          <a:xfrm>
            <a:off x="7692840" y="758880"/>
            <a:ext cx="92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gG2a-F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87"/>
          <p:cNvSpPr/>
          <p:nvPr/>
        </p:nvSpPr>
        <p:spPr>
          <a:xfrm>
            <a:off x="7705800" y="203040"/>
            <a:ext cx="118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o treat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9"/>
          <p:cNvSpPr/>
          <p:nvPr/>
        </p:nvSpPr>
        <p:spPr>
          <a:xfrm>
            <a:off x="0" y="-619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8"/>
          <p:cNvSpPr/>
          <p:nvPr/>
        </p:nvSpPr>
        <p:spPr>
          <a:xfrm>
            <a:off x="228600" y="51120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4713120" y="59544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Ajay Jain</cp:lastModifiedBy>
  <cp:lastPrinted>2012-07-16T16:15:58Z</cp:lastPrinted>
  <dcterms:modified xsi:type="dcterms:W3CDTF">2012-08-16T18:02:19Z</dcterms:modified>
  <cp:revision>432</cp:revision>
  <dc:subject/>
  <dc:title>Slide 1</dc:title>
</cp:coreProperties>
</file>